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6858000" cy="9906000" type="A4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中度样式 2 - 强调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647"/>
    <p:restoredTop sz="97791"/>
  </p:normalViewPr>
  <p:slideViewPr>
    <p:cSldViewPr>
      <p:cViewPr varScale="1">
        <p:scale>
          <a:sx n="64" d="100"/>
          <a:sy n="64" d="100"/>
        </p:scale>
        <p:origin x="3042" y="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2ADDB9-FFE4-7747-9113-1B362A1A7F85}" type="datetimeFigureOut">
              <a:rPr lang="en-US" smtClean="0"/>
              <a:t>9/1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54263" y="1279525"/>
            <a:ext cx="2390775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613" y="4926013"/>
            <a:ext cx="5680075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138" y="972185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624B3B-AA6B-7246-A3E4-1A5EF9C7A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6794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D0938710-E5A8-7740-86DD-B7404F09C9F9}"/>
              </a:ext>
            </a:extLst>
          </p:cNvPr>
          <p:cNvSpPr/>
          <p:nvPr/>
        </p:nvSpPr>
        <p:spPr>
          <a:xfrm>
            <a:off x="260648" y="8697416"/>
            <a:ext cx="633670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H 1.0 scaffolds (y axis) were aligned to GRCh38 (x axis) b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UMm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he red and blue lines indicate the alignments are in the same strand or in the opposite strand, respectively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F763F702-5A6B-FB4F-845C-0BC5639597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92560"/>
            <a:ext cx="6858000" cy="76718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37161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7</TotalTime>
  <Words>39</Words>
  <Application>Microsoft Office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A</cp:lastModifiedBy>
  <cp:revision>217</cp:revision>
  <cp:lastPrinted>2019-01-09T02:33:31Z</cp:lastPrinted>
  <dcterms:created xsi:type="dcterms:W3CDTF">2017-07-18T13:30:22Z</dcterms:created>
  <dcterms:modified xsi:type="dcterms:W3CDTF">2019-08-31T16:45:54Z</dcterms:modified>
</cp:coreProperties>
</file>